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>
      <p:cViewPr varScale="1">
        <p:scale>
          <a:sx n="96" d="100"/>
          <a:sy n="96" d="100"/>
        </p:scale>
        <p:origin x="101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B0DE34-EB8B-48AA-983F-30B4516280E6}" type="datetimeFigureOut">
              <a:rPr lang="en-GB" smtClean="0"/>
              <a:t>17/02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D72A54-5537-489F-BCC7-0D50389A1F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77248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ry Figure 5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6DE0369-B2C4-6D43-ADC3-05123AC987D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9839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17571-7A87-466F-94AF-5E5773D76E90}" type="datetimeFigureOut">
              <a:rPr lang="en-GB" smtClean="0"/>
              <a:t>17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7E5BC-63A3-4404-AC9D-6051321D3D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24261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17571-7A87-466F-94AF-5E5773D76E90}" type="datetimeFigureOut">
              <a:rPr lang="en-GB" smtClean="0"/>
              <a:t>17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7E5BC-63A3-4404-AC9D-6051321D3D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77949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17571-7A87-466F-94AF-5E5773D76E90}" type="datetimeFigureOut">
              <a:rPr lang="en-GB" smtClean="0"/>
              <a:t>17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7E5BC-63A3-4404-AC9D-6051321D3D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00441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17571-7A87-466F-94AF-5E5773D76E90}" type="datetimeFigureOut">
              <a:rPr lang="en-GB" smtClean="0"/>
              <a:t>17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7E5BC-63A3-4404-AC9D-6051321D3D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44669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17571-7A87-466F-94AF-5E5773D76E90}" type="datetimeFigureOut">
              <a:rPr lang="en-GB" smtClean="0"/>
              <a:t>17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7E5BC-63A3-4404-AC9D-6051321D3D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2367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17571-7A87-466F-94AF-5E5773D76E90}" type="datetimeFigureOut">
              <a:rPr lang="en-GB" smtClean="0"/>
              <a:t>17/0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7E5BC-63A3-4404-AC9D-6051321D3D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92969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17571-7A87-466F-94AF-5E5773D76E90}" type="datetimeFigureOut">
              <a:rPr lang="en-GB" smtClean="0"/>
              <a:t>17/02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7E5BC-63A3-4404-AC9D-6051321D3D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22357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17571-7A87-466F-94AF-5E5773D76E90}" type="datetimeFigureOut">
              <a:rPr lang="en-GB" smtClean="0"/>
              <a:t>17/02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7E5BC-63A3-4404-AC9D-6051321D3D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04942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17571-7A87-466F-94AF-5E5773D76E90}" type="datetimeFigureOut">
              <a:rPr lang="en-GB" smtClean="0"/>
              <a:t>17/02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7E5BC-63A3-4404-AC9D-6051321D3D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4993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17571-7A87-466F-94AF-5E5773D76E90}" type="datetimeFigureOut">
              <a:rPr lang="en-GB" smtClean="0"/>
              <a:t>17/0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7E5BC-63A3-4404-AC9D-6051321D3D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92226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917571-7A87-466F-94AF-5E5773D76E90}" type="datetimeFigureOut">
              <a:rPr lang="en-GB" smtClean="0"/>
              <a:t>17/0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7E5BC-63A3-4404-AC9D-6051321D3D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03302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917571-7A87-466F-94AF-5E5773D76E90}" type="datetimeFigureOut">
              <a:rPr lang="en-GB" smtClean="0"/>
              <a:t>17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37E5BC-63A3-4404-AC9D-6051321D3D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30512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9FC5A9BA-FC3A-6049-9546-B5BD5ED4614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6540" y="392097"/>
            <a:ext cx="7826354" cy="56508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750624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652BEAFB-B8F9-304C-9AE1-586D6F33510E}"/>
              </a:ext>
            </a:extLst>
          </p:cNvPr>
          <p:cNvSpPr/>
          <p:nvPr/>
        </p:nvSpPr>
        <p:spPr>
          <a:xfrm>
            <a:off x="463274" y="861206"/>
            <a:ext cx="8919210" cy="34163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b="1" dirty="0">
                <a:latin typeface="Calibri" panose="020F0502020204030204" pitchFamily="34" charset="0"/>
                <a:ea typeface="Calibri" panose="020F0502020204030204" pitchFamily="34" charset="0"/>
              </a:rPr>
              <a:t>Supplementary Figure 4</a:t>
            </a:r>
            <a:r>
              <a:rPr lang="en-GB" b="1" dirty="0" smtClean="0">
                <a:latin typeface="Calibri" panose="020F0502020204030204" pitchFamily="34" charset="0"/>
                <a:ea typeface="Calibri" panose="020F0502020204030204" pitchFamily="34" charset="0"/>
              </a:rPr>
              <a:t>:</a:t>
            </a: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b="1" dirty="0" smtClean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GB" i="1" dirty="0">
                <a:latin typeface="Calibri" panose="020F0502020204030204" pitchFamily="34" charset="0"/>
                <a:ea typeface="Calibri" panose="020F0502020204030204" pitchFamily="34" charset="0"/>
              </a:rPr>
              <a:t>Correlation between Bliss independence score and EPS</a:t>
            </a: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</a:rPr>
              <a:t>The EPS values of individual combination experiments are plotted on the y axis and the corresponding values of the Bliss independent scores are plotted on the x axis. There was no clear correlation between the Bliss independence score and the EPS (R</a:t>
            </a:r>
            <a:r>
              <a:rPr lang="en-GB" baseline="30000" dirty="0">
                <a:latin typeface="Calibri" panose="020F0502020204030204" pitchFamily="34" charset="0"/>
                <a:ea typeface="Calibri" panose="020F0502020204030204" pitchFamily="34" charset="0"/>
              </a:rPr>
              <a:t>2</a:t>
            </a: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</a:rPr>
              <a:t>= 0.0013165).</a:t>
            </a: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b="1" dirty="0">
                <a:latin typeface="Calibri" panose="020F0502020204030204" pitchFamily="34" charset="0"/>
                <a:ea typeface="Calibri" panose="020F0502020204030204" pitchFamily="34" charset="0"/>
              </a:rPr>
              <a:t> </a:t>
            </a:r>
            <a:endParaRPr lang="en-GB" dirty="0"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69315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64</Words>
  <Application>Microsoft Office PowerPoint</Application>
  <PresentationFormat>Widescreen</PresentationFormat>
  <Paragraphs>6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Institute of Cancer Resear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dai Banerji</dc:creator>
  <cp:lastModifiedBy>Udai Banerji</cp:lastModifiedBy>
  <cp:revision>5</cp:revision>
  <dcterms:created xsi:type="dcterms:W3CDTF">2021-01-16T15:07:49Z</dcterms:created>
  <dcterms:modified xsi:type="dcterms:W3CDTF">2022-02-17T05:25:18Z</dcterms:modified>
</cp:coreProperties>
</file>